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5C6D7B-03EC-45A4-972E-B8D944E30E8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3669EB-D97A-4555-A903-D76780434F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23922C-9C2C-415D-9A62-4304BBF0081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92133-961E-4DD9-A1B0-E12D67D7705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C6B5F9-9F54-4204-BEB6-905A8A5A71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C6171A-BD2C-44E7-A5F9-5059841CFF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6AD371-C444-49CA-94FC-D2E37F9478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D878B-5B70-4EAD-BE45-E0F272A5C5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FC7B81-06CC-4E24-892C-67AFAA894B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8F05B0-3763-4D44-862A-071BEFD383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78D190-D549-412C-8F6E-C2D1F5B00E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1E271C-DE71-4E98-AD97-BA748E7454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8AA7517-FFCD-4C44-81B7-1097F751DC6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91" descr=""/>
          <p:cNvPicPr/>
          <p:nvPr/>
        </p:nvPicPr>
        <p:blipFill>
          <a:blip r:embed="rId1"/>
          <a:stretch/>
        </p:blipFill>
        <p:spPr>
          <a:xfrm>
            <a:off x="1568520" y="498600"/>
            <a:ext cx="2411280" cy="2232000"/>
          </a:xfrm>
          <a:prstGeom prst="rect">
            <a:avLst/>
          </a:prstGeom>
          <a:ln w="0">
            <a:noFill/>
          </a:ln>
        </p:spPr>
      </p:pic>
      <p:sp>
        <p:nvSpPr>
          <p:cNvPr id="42" name="TextBox 92"/>
          <p:cNvSpPr/>
          <p:nvPr/>
        </p:nvSpPr>
        <p:spPr>
          <a:xfrm rot="16200000">
            <a:off x="-360" y="1520640"/>
            <a:ext cx="22838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OXA1 mRNA expression level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(Microarray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93"/>
          <p:cNvSpPr/>
          <p:nvPr/>
        </p:nvSpPr>
        <p:spPr>
          <a:xfrm>
            <a:off x="1532520" y="2886120"/>
            <a:ext cx="2413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OXA1 methylation (MeDip; unit)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94"/>
          <p:cNvSpPr/>
          <p:nvPr/>
        </p:nvSpPr>
        <p:spPr>
          <a:xfrm>
            <a:off x="1262880" y="51444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16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95"/>
          <p:cNvSpPr/>
          <p:nvPr/>
        </p:nvSpPr>
        <p:spPr>
          <a:xfrm>
            <a:off x="1251720" y="89676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14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96"/>
          <p:cNvSpPr/>
          <p:nvPr/>
        </p:nvSpPr>
        <p:spPr>
          <a:xfrm>
            <a:off x="1262880" y="127944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1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97"/>
          <p:cNvSpPr/>
          <p:nvPr/>
        </p:nvSpPr>
        <p:spPr>
          <a:xfrm>
            <a:off x="1262880" y="166212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98"/>
          <p:cNvSpPr/>
          <p:nvPr/>
        </p:nvSpPr>
        <p:spPr>
          <a:xfrm>
            <a:off x="1326600" y="204480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99"/>
          <p:cNvSpPr/>
          <p:nvPr/>
        </p:nvSpPr>
        <p:spPr>
          <a:xfrm>
            <a:off x="1326600" y="242712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00"/>
          <p:cNvSpPr/>
          <p:nvPr/>
        </p:nvSpPr>
        <p:spPr>
          <a:xfrm>
            <a:off x="1493280" y="2671920"/>
            <a:ext cx="423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0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01"/>
          <p:cNvSpPr/>
          <p:nvPr/>
        </p:nvSpPr>
        <p:spPr>
          <a:xfrm>
            <a:off x="2063160" y="267192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0.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02"/>
          <p:cNvSpPr/>
          <p:nvPr/>
        </p:nvSpPr>
        <p:spPr>
          <a:xfrm>
            <a:off x="2585520" y="267192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03"/>
          <p:cNvSpPr/>
          <p:nvPr/>
        </p:nvSpPr>
        <p:spPr>
          <a:xfrm>
            <a:off x="3107520" y="267192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04"/>
          <p:cNvSpPr/>
          <p:nvPr/>
        </p:nvSpPr>
        <p:spPr>
          <a:xfrm>
            <a:off x="3629880" y="267192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5" name=""/>
          <p:cNvGraphicFramePr/>
          <p:nvPr/>
        </p:nvGraphicFramePr>
        <p:xfrm>
          <a:off x="655560" y="3645000"/>
          <a:ext cx="5372280" cy="1485720"/>
        </p:xfrm>
        <a:graphic>
          <a:graphicData uri="http://schemas.openxmlformats.org/drawingml/2006/table">
            <a:tbl>
              <a:tblPr/>
              <a:tblGrid>
                <a:gridCol w="61200"/>
                <a:gridCol w="824040"/>
                <a:gridCol w="824040"/>
                <a:gridCol w="824040"/>
                <a:gridCol w="824400"/>
                <a:gridCol w="824040"/>
                <a:gridCol w="367560"/>
                <a:gridCol w="822960"/>
              </a:tblGrid>
              <a:tr h="266760">
                <a:tc gridSpan="8"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near regression between FOXA1 methylation and expressio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030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5"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del Summar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9688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de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 Squar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justed R Squar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Error of the Estim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60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356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3480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0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5"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. Predictors: (Constant), FOXA1 methyl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6" name=""/>
          <p:cNvGraphicFramePr/>
          <p:nvPr/>
        </p:nvGraphicFramePr>
        <p:xfrm>
          <a:off x="655560" y="5365800"/>
          <a:ext cx="5778720" cy="1993680"/>
        </p:xfrm>
        <a:graphic>
          <a:graphicData uri="http://schemas.openxmlformats.org/drawingml/2006/table">
            <a:tbl>
              <a:tblPr/>
              <a:tblGrid>
                <a:gridCol w="825480"/>
                <a:gridCol w="825480"/>
                <a:gridCol w="825480"/>
                <a:gridCol w="825480"/>
                <a:gridCol w="947880"/>
                <a:gridCol w="703440"/>
                <a:gridCol w="825480"/>
              </a:tblGrid>
              <a:tr h="203040">
                <a:tc gridSpan="7"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efficients</a:t>
                      </a:r>
                      <a:r>
                        <a:rPr b="1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787680">
                <a:tc gridSpan="2" rowSpan="2"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de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standardized Coefficient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ndardized Coefficient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03040"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Erro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e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03040">
                <a:tc rowSpan="2"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Constant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.78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.6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93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A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thyl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6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35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2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 gridSpan="7"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. Dependent Variable: FOXA1 express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57" name="TextBox 107"/>
          <p:cNvSpPr/>
          <p:nvPr/>
        </p:nvSpPr>
        <p:spPr>
          <a:xfrm>
            <a:off x="204840" y="322200"/>
            <a:ext cx="412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08"/>
          <p:cNvSpPr/>
          <p:nvPr/>
        </p:nvSpPr>
        <p:spPr>
          <a:xfrm>
            <a:off x="204840" y="3284640"/>
            <a:ext cx="412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9" name="Picture 1" descr=""/>
          <p:cNvPicPr/>
          <p:nvPr/>
        </p:nvPicPr>
        <p:blipFill>
          <a:blip r:embed="rId2"/>
          <a:stretch/>
        </p:blipFill>
        <p:spPr>
          <a:xfrm>
            <a:off x="3249720" y="565200"/>
            <a:ext cx="628560" cy="276120"/>
          </a:xfrm>
          <a:prstGeom prst="rect">
            <a:avLst/>
          </a:prstGeom>
          <a:ln w="0">
            <a:noFill/>
          </a:ln>
        </p:spPr>
      </p:pic>
      <p:sp>
        <p:nvSpPr>
          <p:cNvPr id="60" name="TextBox 20"/>
          <p:cNvSpPr/>
          <p:nvPr/>
        </p:nvSpPr>
        <p:spPr>
          <a:xfrm>
            <a:off x="5080680" y="9609120"/>
            <a:ext cx="178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 S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16T23:48:49Z</dcterms:created>
  <dc:creator>Jade Gong</dc:creator>
  <dc:description/>
  <dc:language>en-US</dc:language>
  <cp:lastModifiedBy>Eric Lam</cp:lastModifiedBy>
  <cp:lastPrinted>2014-09-26T09:57:40Z</cp:lastPrinted>
  <dcterms:modified xsi:type="dcterms:W3CDTF">2014-10-01T11:20:07Z</dcterms:modified>
  <cp:revision>591</cp:revision>
  <dc:subject/>
  <dc:title>PowerPoint Presentation</dc:title>
</cp:coreProperties>
</file>